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8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55E90"/>
    <a:srgbClr val="6C8FB0"/>
    <a:srgbClr val="255E91"/>
    <a:srgbClr val="F1ECEC"/>
    <a:srgbClr val="4472C4"/>
    <a:srgbClr val="70AC47"/>
    <a:srgbClr val="F1EBEB"/>
    <a:srgbClr val="FFC000"/>
    <a:srgbClr val="A5A5A5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6238" autoAdjust="0"/>
  </p:normalViewPr>
  <p:slideViewPr>
    <p:cSldViewPr snapToGrid="0">
      <p:cViewPr varScale="1">
        <p:scale>
          <a:sx n="74" d="100"/>
          <a:sy n="74" d="100"/>
        </p:scale>
        <p:origin x="2214" y="84"/>
      </p:cViewPr>
      <p:guideLst>
        <p:guide orient="horz" pos="298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0C158D-F809-47F0-B9C5-91A2479D11A7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CA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0C58D9-8E3D-43F4-8BE8-6BA9F2C2CEC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08661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0C58D9-8E3D-43F4-8BE8-6BA9F2C2CEC4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374241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166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72546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482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1896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5846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1474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65267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4136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0078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73599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51481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4E733-1F4F-4E8C-9BD3-98BD55711EAA}" type="datetimeFigureOut">
              <a:rPr lang="en-CA" smtClean="0"/>
              <a:t>2023-03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15CA6C-5C28-4C11-A67E-578971BBE4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02711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4983" y="3176425"/>
            <a:ext cx="2582963" cy="1987901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0196" y="1458230"/>
            <a:ext cx="2382754" cy="146082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29396" y="3170118"/>
            <a:ext cx="1766213" cy="190353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66433" y="118501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916340" y="1185019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72845" y="304107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916340" y="3041073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2E76FD5F-220F-63EE-E61E-EB99A68E080B}"/>
              </a:ext>
            </a:extLst>
          </p:cNvPr>
          <p:cNvGrpSpPr/>
          <p:nvPr/>
        </p:nvGrpSpPr>
        <p:grpSpPr>
          <a:xfrm>
            <a:off x="3254796" y="1121806"/>
            <a:ext cx="3131146" cy="941652"/>
            <a:chOff x="3525610" y="3039864"/>
            <a:chExt cx="3131146" cy="941652"/>
          </a:xfrm>
        </p:grpSpPr>
        <p:pic>
          <p:nvPicPr>
            <p:cNvPr id="14" name="图片 13"/>
            <p:cNvPicPr/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-1"/>
            <a:stretch/>
          </p:blipFill>
          <p:spPr>
            <a:xfrm>
              <a:off x="3581966" y="3207037"/>
              <a:ext cx="3074790" cy="774479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E9EEF90-300D-FC74-F512-0357CB1CD7BE}"/>
                </a:ext>
              </a:extLst>
            </p:cNvPr>
            <p:cNvSpPr txBox="1"/>
            <p:nvPr/>
          </p:nvSpPr>
          <p:spPr>
            <a:xfrm>
              <a:off x="3525610" y="3039864"/>
              <a:ext cx="209414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</a:rPr>
                <a:t>Assessments of genome assembly by BUSCO</a:t>
              </a:r>
              <a:endParaRPr lang="zh-CN" altLang="en-US" sz="800" dirty="0"/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6D1F9AF8-9B56-8A38-F34B-963D87D6BE24}"/>
              </a:ext>
            </a:extLst>
          </p:cNvPr>
          <p:cNvGrpSpPr/>
          <p:nvPr/>
        </p:nvGrpSpPr>
        <p:grpSpPr>
          <a:xfrm>
            <a:off x="3254796" y="2069597"/>
            <a:ext cx="3429000" cy="943439"/>
            <a:chOff x="3525610" y="3860655"/>
            <a:chExt cx="3429000" cy="943439"/>
          </a:xfrm>
        </p:grpSpPr>
        <p:pic>
          <p:nvPicPr>
            <p:cNvPr id="13" name="图片 12"/>
            <p:cNvPicPr/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81966" y="4027808"/>
              <a:ext cx="3074790" cy="776286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CE34F340-BA05-CB1C-83A5-B69FBD2B6E0C}"/>
                </a:ext>
              </a:extLst>
            </p:cNvPr>
            <p:cNvSpPr txBox="1"/>
            <p:nvPr/>
          </p:nvSpPr>
          <p:spPr>
            <a:xfrm>
              <a:off x="3525610" y="3860655"/>
              <a:ext cx="342900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</a:rPr>
                <a:t>Assessments of functional annotation by BUSCO</a:t>
              </a:r>
              <a:endParaRPr lang="zh-CN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987459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35</TotalTime>
  <Words>25</Words>
  <Application>Microsoft Office PowerPoint</Application>
  <PresentationFormat>A4 纸张(210x297 毫米)</PresentationFormat>
  <Paragraphs>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</dc:creator>
  <cp:lastModifiedBy>Lyu Shanwu</cp:lastModifiedBy>
  <cp:revision>242</cp:revision>
  <dcterms:created xsi:type="dcterms:W3CDTF">2022-06-05T08:19:44Z</dcterms:created>
  <dcterms:modified xsi:type="dcterms:W3CDTF">2023-03-29T00:34:57Z</dcterms:modified>
</cp:coreProperties>
</file>